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</p:sldIdLst>
  <p:sldSz cx="12599988" cy="8280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6C384EE9-6C63-430F-8AF6-90E46356B1E7}" v="5" dt="2023-12-27T01:25:56.193"/>
    <p1510:client id="{7195441E-49BE-4972-85CA-C0E1F969063C}" v="1" dt="2023-12-27T01:29:30.628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94" d="100"/>
          <a:sy n="94" d="100"/>
        </p:scale>
        <p:origin x="512" y="8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Kyuwoong Kim" userId="c6581f603476f281" providerId="LiveId" clId="{6C384EE9-6C63-430F-8AF6-90E46356B1E7}"/>
    <pc:docChg chg="undo custSel modSld">
      <pc:chgData name="Kyuwoong Kim" userId="c6581f603476f281" providerId="LiveId" clId="{6C384EE9-6C63-430F-8AF6-90E46356B1E7}" dt="2023-12-27T01:26:20.300" v="94" actId="1076"/>
      <pc:docMkLst>
        <pc:docMk/>
      </pc:docMkLst>
      <pc:sldChg chg="addSp delSp modSp mod">
        <pc:chgData name="Kyuwoong Kim" userId="c6581f603476f281" providerId="LiveId" clId="{6C384EE9-6C63-430F-8AF6-90E46356B1E7}" dt="2023-12-27T01:26:20.300" v="94" actId="1076"/>
        <pc:sldMkLst>
          <pc:docMk/>
          <pc:sldMk cId="1037682986" sldId="257"/>
        </pc:sldMkLst>
        <pc:spChg chg="add mod">
          <ac:chgData name="Kyuwoong Kim" userId="c6581f603476f281" providerId="LiveId" clId="{6C384EE9-6C63-430F-8AF6-90E46356B1E7}" dt="2023-12-27T01:26:04.982" v="92" actId="20577"/>
          <ac:spMkLst>
            <pc:docMk/>
            <pc:sldMk cId="1037682986" sldId="257"/>
            <ac:spMk id="12" creationId="{D9CF38EF-56BB-5B5F-9603-974CFEE48FEC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15" creationId="{0110422B-A330-DB43-E93C-5DF9FB920B6B}"/>
          </ac:spMkLst>
        </pc:spChg>
        <pc:spChg chg="mod or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21" creationId="{12112411-3BB9-15BD-96F2-4DFAD9EE62C8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3" creationId="{F7621210-4DEB-DC03-123C-1F7219027A33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4" creationId="{0F4EDBFB-743C-9551-9B31-900B8968843C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5" creationId="{70AB1660-B3CE-77D2-5D8C-D8408DC702D9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6" creationId="{41517E53-6946-C0A4-3CEB-705AB7147267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7" creationId="{536D7B9A-9813-1BD4-26D6-5FCAFEC49DC0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8" creationId="{75830CAC-6B12-E0E8-422D-B6C9400A1632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39" creationId="{59842221-111E-3077-4793-03A331493134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0" creationId="{E1EB41B9-F25F-6955-8F1D-4E3E210433FC}"/>
          </ac:spMkLst>
        </pc:spChg>
        <pc:spChg chg="mod or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1" creationId="{681649CF-8F1A-BE31-7BC6-0C48E9FF9B97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3" creationId="{EB886F77-C41C-CC57-767F-E8CFA9FF7E04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4" creationId="{1B923759-EE7D-5F6F-083F-A2A6D42FF4E3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5" creationId="{8E099F1B-C4B0-CB68-3D46-F97CB0D9FA0B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6" creationId="{266B1B07-D5D4-8078-C2BF-925F81997393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7" creationId="{4CFE6C89-8253-9163-0D05-478393A537F7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8" creationId="{622735BE-5519-093A-F7CB-E3D635556409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49" creationId="{B0515DB5-2198-0BD1-261B-331C1CC43A0F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0" creationId="{28E6E8D2-F0CF-7635-08AB-13818695D9FD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1" creationId="{58E86152-40C0-3EC5-B47C-887EC496857E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2" creationId="{A76C66C2-A7C7-B858-D717-0AAC2D46539E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3" creationId="{2A47FEAD-69CC-726F-A02C-A9A4AC48BC06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4" creationId="{6717F8D1-BF07-A098-4DC1-4AAD52E17891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5" creationId="{EF4E0080-96C2-16C3-95B9-1A58C94F5A70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6" creationId="{A8E53E1A-EAD9-987A-69DE-A3539E8F3A24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7" creationId="{D8599CB8-A876-D470-D910-AF42CADEE583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8" creationId="{DD4F08F9-5B11-7390-36F3-DB8D8A134D9B}"/>
          </ac:spMkLst>
        </pc:spChg>
        <pc:spChg chg="mod">
          <ac:chgData name="Kyuwoong Kim" userId="c6581f603476f281" providerId="LiveId" clId="{6C384EE9-6C63-430F-8AF6-90E46356B1E7}" dt="2023-12-27T01:26:20.300" v="94" actId="1076"/>
          <ac:spMkLst>
            <pc:docMk/>
            <pc:sldMk cId="1037682986" sldId="257"/>
            <ac:spMk id="59" creationId="{3EDD9793-3B26-CE2E-C2F8-BFE20E640AE8}"/>
          </ac:spMkLst>
        </pc:sp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2" creationId="{89F1FC39-C451-D940-77C3-EB949E3015FC}"/>
          </ac:picMkLst>
        </pc:picChg>
        <pc:picChg chg="del">
          <ac:chgData name="Kyuwoong Kim" userId="c6581f603476f281" providerId="LiveId" clId="{6C384EE9-6C63-430F-8AF6-90E46356B1E7}" dt="2023-12-27T01:21:36.465" v="2" actId="478"/>
          <ac:picMkLst>
            <pc:docMk/>
            <pc:sldMk cId="1037682986" sldId="257"/>
            <ac:picMk id="3" creationId="{3DA2BF18-C613-9863-29D7-87EE3DC84849}"/>
          </ac:picMkLst>
        </pc:pic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4" creationId="{78CFC0BB-A8AA-3A99-B3A4-0F096EF75EF2}"/>
          </ac:picMkLst>
        </pc:pic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5" creationId="{B7846E34-7695-90B4-ED71-8D35E87029BD}"/>
          </ac:picMkLst>
        </pc:pic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6" creationId="{05B99E67-0C4F-310E-2828-FDAFE392684F}"/>
          </ac:picMkLst>
        </pc:picChg>
        <pc:picChg chg="del">
          <ac:chgData name="Kyuwoong Kim" userId="c6581f603476f281" providerId="LiveId" clId="{6C384EE9-6C63-430F-8AF6-90E46356B1E7}" dt="2023-12-27T01:21:35.980" v="1" actId="478"/>
          <ac:picMkLst>
            <pc:docMk/>
            <pc:sldMk cId="1037682986" sldId="257"/>
            <ac:picMk id="7" creationId="{7C63AA1C-3B9F-F182-95A6-FFB796DF3BDF}"/>
          </ac:picMkLst>
        </pc:picChg>
        <pc:picChg chg="del">
          <ac:chgData name="Kyuwoong Kim" userId="c6581f603476f281" providerId="LiveId" clId="{6C384EE9-6C63-430F-8AF6-90E46356B1E7}" dt="2023-12-27T01:21:35.406" v="0" actId="478"/>
          <ac:picMkLst>
            <pc:docMk/>
            <pc:sldMk cId="1037682986" sldId="257"/>
            <ac:picMk id="8" creationId="{9ADBDB19-291D-762F-285E-37BC4E4DD745}"/>
          </ac:picMkLst>
        </pc:picChg>
        <pc:picChg chg="del">
          <ac:chgData name="Kyuwoong Kim" userId="c6581f603476f281" providerId="LiveId" clId="{6C384EE9-6C63-430F-8AF6-90E46356B1E7}" dt="2023-12-27T01:21:37.949" v="5" actId="478"/>
          <ac:picMkLst>
            <pc:docMk/>
            <pc:sldMk cId="1037682986" sldId="257"/>
            <ac:picMk id="9" creationId="{07E698BB-6FF8-6B7E-9D41-A0B8AC24415D}"/>
          </ac:picMkLst>
        </pc:pic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10" creationId="{184CEB08-BB23-794B-AD8A-86F485ED0A75}"/>
          </ac:picMkLst>
        </pc:picChg>
        <pc:picChg chg="add mod ord">
          <ac:chgData name="Kyuwoong Kim" userId="c6581f603476f281" providerId="LiveId" clId="{6C384EE9-6C63-430F-8AF6-90E46356B1E7}" dt="2023-12-27T01:26:20.300" v="94" actId="1076"/>
          <ac:picMkLst>
            <pc:docMk/>
            <pc:sldMk cId="1037682986" sldId="257"/>
            <ac:picMk id="11" creationId="{0D3255E8-C6D7-5AB4-41DB-A9E9AED6C338}"/>
          </ac:picMkLst>
        </pc:picChg>
        <pc:picChg chg="del">
          <ac:chgData name="Kyuwoong Kim" userId="c6581f603476f281" providerId="LiveId" clId="{6C384EE9-6C63-430F-8AF6-90E46356B1E7}" dt="2023-12-27T01:21:37.442" v="4" actId="478"/>
          <ac:picMkLst>
            <pc:docMk/>
            <pc:sldMk cId="1037682986" sldId="257"/>
            <ac:picMk id="13" creationId="{B53CCBB4-0B80-D41A-BC82-1969AE576977}"/>
          </ac:picMkLst>
        </pc:picChg>
        <pc:picChg chg="del">
          <ac:chgData name="Kyuwoong Kim" userId="c6581f603476f281" providerId="LiveId" clId="{6C384EE9-6C63-430F-8AF6-90E46356B1E7}" dt="2023-12-27T01:21:37.016" v="3" actId="478"/>
          <ac:picMkLst>
            <pc:docMk/>
            <pc:sldMk cId="1037682986" sldId="257"/>
            <ac:picMk id="14" creationId="{9B354F50-063D-9DB5-9BDE-88FD7F5DC280}"/>
          </ac:picMkLst>
        </pc:picChg>
      </pc:sldChg>
    </pc:docChg>
  </pc:docChgLst>
  <pc:docChgLst>
    <pc:chgData name="Kyuwoong Kim" userId="c6581f603476f281" providerId="LiveId" clId="{AB3AD8FA-EAF4-40B3-BC33-1A83D204ECFD}"/>
    <pc:docChg chg="undo custSel modSld">
      <pc:chgData name="Kyuwoong Kim" userId="c6581f603476f281" providerId="LiveId" clId="{AB3AD8FA-EAF4-40B3-BC33-1A83D204ECFD}" dt="2023-12-22T02:31:49.804" v="328" actId="20577"/>
      <pc:docMkLst>
        <pc:docMk/>
      </pc:docMkLst>
      <pc:sldChg chg="addSp delSp modSp mod">
        <pc:chgData name="Kyuwoong Kim" userId="c6581f603476f281" providerId="LiveId" clId="{AB3AD8FA-EAF4-40B3-BC33-1A83D204ECFD}" dt="2023-12-22T02:31:49.804" v="328" actId="20577"/>
        <pc:sldMkLst>
          <pc:docMk/>
          <pc:sldMk cId="1037682986" sldId="257"/>
        </pc:sldMkLst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" creationId="{5F4CB461-2D7B-9907-267D-13399AEB1AD4}"/>
          </ac:spMkLst>
        </pc:spChg>
        <pc:spChg chg="add mod">
          <ac:chgData name="Kyuwoong Kim" userId="c6581f603476f281" providerId="LiveId" clId="{AB3AD8FA-EAF4-40B3-BC33-1A83D204ECFD}" dt="2023-12-22T02:31:49.804" v="328" actId="20577"/>
          <ac:spMkLst>
            <pc:docMk/>
            <pc:sldMk cId="1037682986" sldId="257"/>
            <ac:spMk id="15" creationId="{0110422B-A330-DB43-E93C-5DF9FB920B6B}"/>
          </ac:spMkLst>
        </pc:spChg>
        <pc:spChg chg="add del mod">
          <ac:chgData name="Kyuwoong Kim" userId="c6581f603476f281" providerId="LiveId" clId="{AB3AD8FA-EAF4-40B3-BC33-1A83D204ECFD}" dt="2023-12-22T01:51:12.077" v="157" actId="478"/>
          <ac:spMkLst>
            <pc:docMk/>
            <pc:sldMk cId="1037682986" sldId="257"/>
            <ac:spMk id="16" creationId="{8AB8FFF6-C704-2E86-DF92-794B3C588EA3}"/>
          </ac:spMkLst>
        </pc:spChg>
        <pc:spChg chg="add del mod">
          <ac:chgData name="Kyuwoong Kim" userId="c6581f603476f281" providerId="LiveId" clId="{AB3AD8FA-EAF4-40B3-BC33-1A83D204ECFD}" dt="2023-12-22T01:51:14.189" v="158" actId="478"/>
          <ac:spMkLst>
            <pc:docMk/>
            <pc:sldMk cId="1037682986" sldId="257"/>
            <ac:spMk id="17" creationId="{6DA3FB4B-36A2-59BE-3D23-1D7D35BB8FD2}"/>
          </ac:spMkLst>
        </pc:spChg>
        <pc:spChg chg="add del mod">
          <ac:chgData name="Kyuwoong Kim" userId="c6581f603476f281" providerId="LiveId" clId="{AB3AD8FA-EAF4-40B3-BC33-1A83D204ECFD}" dt="2023-12-22T01:51:16.108" v="159" actId="478"/>
          <ac:spMkLst>
            <pc:docMk/>
            <pc:sldMk cId="1037682986" sldId="257"/>
            <ac:spMk id="18" creationId="{3F5E720C-6459-2406-81C8-4FA1EE564878}"/>
          </ac:spMkLst>
        </pc:spChg>
        <pc:spChg chg="add del mod">
          <ac:chgData name="Kyuwoong Kim" userId="c6581f603476f281" providerId="LiveId" clId="{AB3AD8FA-EAF4-40B3-BC33-1A83D204ECFD}" dt="2023-12-22T01:51:17.217" v="160" actId="478"/>
          <ac:spMkLst>
            <pc:docMk/>
            <pc:sldMk cId="1037682986" sldId="257"/>
            <ac:spMk id="19" creationId="{72849703-0F90-A9B9-ED24-D814A8097F51}"/>
          </ac:spMkLst>
        </pc:spChg>
        <pc:spChg chg="add del mod">
          <ac:chgData name="Kyuwoong Kim" userId="c6581f603476f281" providerId="LiveId" clId="{AB3AD8FA-EAF4-40B3-BC33-1A83D204ECFD}" dt="2023-12-22T01:51:18.431" v="161" actId="478"/>
          <ac:spMkLst>
            <pc:docMk/>
            <pc:sldMk cId="1037682986" sldId="257"/>
            <ac:spMk id="20" creationId="{8CEB927C-7706-70D6-FDC5-BCA69BD655AD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21" creationId="{12112411-3BB9-15BD-96F2-4DFAD9EE62C8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2" creationId="{21BF83AB-55A3-F8DC-0AC5-9BAB80BDCDE9}"/>
          </ac:spMkLst>
        </pc:spChg>
        <pc:spChg chg="del">
          <ac:chgData name="Kyuwoong Kim" userId="c6581f603476f281" providerId="LiveId" clId="{AB3AD8FA-EAF4-40B3-BC33-1A83D204ECFD}" dt="2023-12-22T01:43:46.770" v="1" actId="478"/>
          <ac:spMkLst>
            <pc:docMk/>
            <pc:sldMk cId="1037682986" sldId="257"/>
            <ac:spMk id="23" creationId="{1489FC61-41C2-11CB-9C3F-8D4E13252A84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4" creationId="{9B18D7A9-F4A3-439B-BAC6-01EA93319108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5" creationId="{0CDCDC3F-BCC9-07D3-BFF9-B851EC094AF4}"/>
          </ac:spMkLst>
        </pc:spChg>
        <pc:spChg chg="del">
          <ac:chgData name="Kyuwoong Kim" userId="c6581f603476f281" providerId="LiveId" clId="{AB3AD8FA-EAF4-40B3-BC33-1A83D204ECFD}" dt="2023-12-22T01:43:46.770" v="1" actId="478"/>
          <ac:spMkLst>
            <pc:docMk/>
            <pc:sldMk cId="1037682986" sldId="257"/>
            <ac:spMk id="26" creationId="{BCDA9B84-EFA7-F085-870A-66C700B40AE6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7" creationId="{E847B7FE-C20F-8DDD-35A2-E1F6530A4C2D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8" creationId="{49D37221-D60E-1483-6A81-C4EDFF92F184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29" creationId="{966520C8-1DD6-B778-F62E-B052E26DA917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30" creationId="{1BA8DCDA-7410-3AA5-557C-54A052C1965A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31" creationId="{7EC138EB-071C-CE0C-9776-C14A25101744}"/>
          </ac:spMkLst>
        </pc:spChg>
        <pc:spChg chg="del">
          <ac:chgData name="Kyuwoong Kim" userId="c6581f603476f281" providerId="LiveId" clId="{AB3AD8FA-EAF4-40B3-BC33-1A83D204ECFD}" dt="2023-12-22T01:43:43.821" v="0" actId="478"/>
          <ac:spMkLst>
            <pc:docMk/>
            <pc:sldMk cId="1037682986" sldId="257"/>
            <ac:spMk id="32" creationId="{576E202D-A068-46B9-195A-063327A51F07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33" creationId="{F7621210-4DEB-DC03-123C-1F7219027A33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34" creationId="{0F4EDBFB-743C-9551-9B31-900B8968843C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35" creationId="{70AB1660-B3CE-77D2-5D8C-D8408DC702D9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36" creationId="{41517E53-6946-C0A4-3CEB-705AB7147267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37" creationId="{536D7B9A-9813-1BD4-26D6-5FCAFEC49DC0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38" creationId="{75830CAC-6B12-E0E8-422D-B6C9400A1632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39" creationId="{59842221-111E-3077-4793-03A331493134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40" creationId="{E1EB41B9-F25F-6955-8F1D-4E3E210433FC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41" creationId="{681649CF-8F1A-BE31-7BC6-0C48E9FF9B97}"/>
          </ac:spMkLst>
        </pc:spChg>
        <pc:spChg chg="add del mod">
          <ac:chgData name="Kyuwoong Kim" userId="c6581f603476f281" providerId="LiveId" clId="{AB3AD8FA-EAF4-40B3-BC33-1A83D204ECFD}" dt="2023-12-22T01:51:02.103" v="142" actId="478"/>
          <ac:spMkLst>
            <pc:docMk/>
            <pc:sldMk cId="1037682986" sldId="257"/>
            <ac:spMk id="42" creationId="{7933FCEF-10E0-36C5-EEB4-98B317E8E4E7}"/>
          </ac:spMkLst>
        </pc:spChg>
        <pc:spChg chg="add mod">
          <ac:chgData name="Kyuwoong Kim" userId="c6581f603476f281" providerId="LiveId" clId="{AB3AD8FA-EAF4-40B3-BC33-1A83D204ECFD}" dt="2023-12-22T02:09:50.979" v="295" actId="1076"/>
          <ac:spMkLst>
            <pc:docMk/>
            <pc:sldMk cId="1037682986" sldId="257"/>
            <ac:spMk id="43" creationId="{EB886F77-C41C-CC57-767F-E8CFA9FF7E04}"/>
          </ac:spMkLst>
        </pc:spChg>
        <pc:spChg chg="add mod">
          <ac:chgData name="Kyuwoong Kim" userId="c6581f603476f281" providerId="LiveId" clId="{AB3AD8FA-EAF4-40B3-BC33-1A83D204ECFD}" dt="2023-12-22T02:09:55.309" v="296" actId="1076"/>
          <ac:spMkLst>
            <pc:docMk/>
            <pc:sldMk cId="1037682986" sldId="257"/>
            <ac:spMk id="44" creationId="{1B923759-EE7D-5F6F-083F-A2A6D42FF4E3}"/>
          </ac:spMkLst>
        </pc:spChg>
        <pc:spChg chg="add mod">
          <ac:chgData name="Kyuwoong Kim" userId="c6581f603476f281" providerId="LiveId" clId="{AB3AD8FA-EAF4-40B3-BC33-1A83D204ECFD}" dt="2023-12-22T02:09:36.642" v="293" actId="1076"/>
          <ac:spMkLst>
            <pc:docMk/>
            <pc:sldMk cId="1037682986" sldId="257"/>
            <ac:spMk id="45" creationId="{8E099F1B-C4B0-CB68-3D46-F97CB0D9FA0B}"/>
          </ac:spMkLst>
        </pc:spChg>
        <pc:spChg chg="add mod">
          <ac:chgData name="Kyuwoong Kim" userId="c6581f603476f281" providerId="LiveId" clId="{AB3AD8FA-EAF4-40B3-BC33-1A83D204ECFD}" dt="2023-12-22T02:09:31.376" v="292" actId="1076"/>
          <ac:spMkLst>
            <pc:docMk/>
            <pc:sldMk cId="1037682986" sldId="257"/>
            <ac:spMk id="46" creationId="{266B1B07-D5D4-8078-C2BF-925F81997393}"/>
          </ac:spMkLst>
        </pc:spChg>
        <pc:spChg chg="add mod">
          <ac:chgData name="Kyuwoong Kim" userId="c6581f603476f281" providerId="LiveId" clId="{AB3AD8FA-EAF4-40B3-BC33-1A83D204ECFD}" dt="2023-12-22T02:09:27.982" v="291" actId="1076"/>
          <ac:spMkLst>
            <pc:docMk/>
            <pc:sldMk cId="1037682986" sldId="257"/>
            <ac:spMk id="47" creationId="{4CFE6C89-8253-9163-0D05-478393A537F7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48" creationId="{622735BE-5519-093A-F7CB-E3D635556409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49" creationId="{B0515DB5-2198-0BD1-261B-331C1CC43A0F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50" creationId="{28E6E8D2-F0CF-7635-08AB-13818695D9FD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51" creationId="{58E86152-40C0-3EC5-B47C-887EC496857E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52" creationId="{A76C66C2-A7C7-B858-D717-0AAC2D46539E}"/>
          </ac:spMkLst>
        </pc:spChg>
        <pc:spChg chg="add mod">
          <ac:chgData name="Kyuwoong Kim" userId="c6581f603476f281" providerId="LiveId" clId="{AB3AD8FA-EAF4-40B3-BC33-1A83D204ECFD}" dt="2023-12-22T02:08:51.164" v="288" actId="1076"/>
          <ac:spMkLst>
            <pc:docMk/>
            <pc:sldMk cId="1037682986" sldId="257"/>
            <ac:spMk id="53" creationId="{2A47FEAD-69CC-726F-A02C-A9A4AC48BC06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4" creationId="{6717F8D1-BF07-A098-4DC1-4AAD52E17891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5" creationId="{EF4E0080-96C2-16C3-95B9-1A58C94F5A70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6" creationId="{A8E53E1A-EAD9-987A-69DE-A3539E8F3A24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7" creationId="{D8599CB8-A876-D470-D910-AF42CADEE583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8" creationId="{DD4F08F9-5B11-7390-36F3-DB8D8A134D9B}"/>
          </ac:spMkLst>
        </pc:spChg>
        <pc:spChg chg="add mod">
          <ac:chgData name="Kyuwoong Kim" userId="c6581f603476f281" providerId="LiveId" clId="{AB3AD8FA-EAF4-40B3-BC33-1A83D204ECFD}" dt="2023-12-22T02:08:22.129" v="281" actId="1076"/>
          <ac:spMkLst>
            <pc:docMk/>
            <pc:sldMk cId="1037682986" sldId="257"/>
            <ac:spMk id="59" creationId="{3EDD9793-3B26-CE2E-C2F8-BFE20E640AE8}"/>
          </ac:spMkLst>
        </pc:spChg>
        <pc:spChg chg="add del mod">
          <ac:chgData name="Kyuwoong Kim" userId="c6581f603476f281" providerId="LiveId" clId="{AB3AD8FA-EAF4-40B3-BC33-1A83D204ECFD}" dt="2023-12-22T02:00:22.995" v="272"/>
          <ac:spMkLst>
            <pc:docMk/>
            <pc:sldMk cId="1037682986" sldId="257"/>
            <ac:spMk id="60" creationId="{E6ACCB72-2541-97A9-687F-17437B9C1537}"/>
          </ac:spMkLst>
        </pc:spChg>
        <pc:spChg chg="add del mod">
          <ac:chgData name="Kyuwoong Kim" userId="c6581f603476f281" providerId="LiveId" clId="{AB3AD8FA-EAF4-40B3-BC33-1A83D204ECFD}" dt="2023-12-22T02:00:22.995" v="272"/>
          <ac:spMkLst>
            <pc:docMk/>
            <pc:sldMk cId="1037682986" sldId="257"/>
            <ac:spMk id="61" creationId="{7FD862BE-D982-6681-A574-5B95AE049C4E}"/>
          </ac:spMkLst>
        </pc:spChg>
        <pc:picChg chg="add mod">
          <ac:chgData name="Kyuwoong Kim" userId="c6581f603476f281" providerId="LiveId" clId="{AB3AD8FA-EAF4-40B3-BC33-1A83D204ECFD}" dt="2023-12-22T02:08:22.129" v="281" actId="1076"/>
          <ac:picMkLst>
            <pc:docMk/>
            <pc:sldMk cId="1037682986" sldId="257"/>
            <ac:picMk id="3" creationId="{3DA2BF18-C613-9863-29D7-87EE3DC84849}"/>
          </ac:picMkLst>
        </pc:picChg>
        <pc:picChg chg="del">
          <ac:chgData name="Kyuwoong Kim" userId="c6581f603476f281" providerId="LiveId" clId="{AB3AD8FA-EAF4-40B3-BC33-1A83D204ECFD}" dt="2023-12-22T01:43:43.821" v="0" actId="478"/>
          <ac:picMkLst>
            <pc:docMk/>
            <pc:sldMk cId="1037682986" sldId="257"/>
            <ac:picMk id="4" creationId="{76F9B603-6D8E-F714-AEE6-F98BC0ACA0D4}"/>
          </ac:picMkLst>
        </pc:picChg>
        <pc:picChg chg="del">
          <ac:chgData name="Kyuwoong Kim" userId="c6581f603476f281" providerId="LiveId" clId="{AB3AD8FA-EAF4-40B3-BC33-1A83D204ECFD}" dt="2023-12-22T01:43:43.821" v="0" actId="478"/>
          <ac:picMkLst>
            <pc:docMk/>
            <pc:sldMk cId="1037682986" sldId="257"/>
            <ac:picMk id="5" creationId="{2930E2AB-5636-ECD4-5001-902CEB82A9B1}"/>
          </ac:picMkLst>
        </pc:picChg>
        <pc:picChg chg="del">
          <ac:chgData name="Kyuwoong Kim" userId="c6581f603476f281" providerId="LiveId" clId="{AB3AD8FA-EAF4-40B3-BC33-1A83D204ECFD}" dt="2023-12-22T01:43:46.770" v="1" actId="478"/>
          <ac:picMkLst>
            <pc:docMk/>
            <pc:sldMk cId="1037682986" sldId="257"/>
            <ac:picMk id="6" creationId="{3FB8751E-6F08-3B21-DDF5-36C5D992C365}"/>
          </ac:picMkLst>
        </pc:picChg>
        <pc:picChg chg="add mod">
          <ac:chgData name="Kyuwoong Kim" userId="c6581f603476f281" providerId="LiveId" clId="{AB3AD8FA-EAF4-40B3-BC33-1A83D204ECFD}" dt="2023-12-22T02:08:22.129" v="281" actId="1076"/>
          <ac:picMkLst>
            <pc:docMk/>
            <pc:sldMk cId="1037682986" sldId="257"/>
            <ac:picMk id="7" creationId="{7C63AA1C-3B9F-F182-95A6-FFB796DF3BDF}"/>
          </ac:picMkLst>
        </pc:picChg>
        <pc:picChg chg="add mod">
          <ac:chgData name="Kyuwoong Kim" userId="c6581f603476f281" providerId="LiveId" clId="{AB3AD8FA-EAF4-40B3-BC33-1A83D204ECFD}" dt="2023-12-22T02:08:22.129" v="281" actId="1076"/>
          <ac:picMkLst>
            <pc:docMk/>
            <pc:sldMk cId="1037682986" sldId="257"/>
            <ac:picMk id="8" creationId="{9ADBDB19-291D-762F-285E-37BC4E4DD745}"/>
          </ac:picMkLst>
        </pc:picChg>
        <pc:picChg chg="add mod">
          <ac:chgData name="Kyuwoong Kim" userId="c6581f603476f281" providerId="LiveId" clId="{AB3AD8FA-EAF4-40B3-BC33-1A83D204ECFD}" dt="2023-12-22T02:08:51.164" v="288" actId="1076"/>
          <ac:picMkLst>
            <pc:docMk/>
            <pc:sldMk cId="1037682986" sldId="257"/>
            <ac:picMk id="9" creationId="{07E698BB-6FF8-6B7E-9D41-A0B8AC24415D}"/>
          </ac:picMkLst>
        </pc:picChg>
        <pc:picChg chg="del">
          <ac:chgData name="Kyuwoong Kim" userId="c6581f603476f281" providerId="LiveId" clId="{AB3AD8FA-EAF4-40B3-BC33-1A83D204ECFD}" dt="2023-12-22T01:43:43.821" v="0" actId="478"/>
          <ac:picMkLst>
            <pc:docMk/>
            <pc:sldMk cId="1037682986" sldId="257"/>
            <ac:picMk id="10" creationId="{54EAECFE-5401-E253-5BC5-E2B323C35487}"/>
          </ac:picMkLst>
        </pc:picChg>
        <pc:picChg chg="del">
          <ac:chgData name="Kyuwoong Kim" userId="c6581f603476f281" providerId="LiveId" clId="{AB3AD8FA-EAF4-40B3-BC33-1A83D204ECFD}" dt="2023-12-22T01:43:43.821" v="0" actId="478"/>
          <ac:picMkLst>
            <pc:docMk/>
            <pc:sldMk cId="1037682986" sldId="257"/>
            <ac:picMk id="11" creationId="{425BBB78-A5C7-415B-792D-222BB52967C7}"/>
          </ac:picMkLst>
        </pc:picChg>
        <pc:picChg chg="del">
          <ac:chgData name="Kyuwoong Kim" userId="c6581f603476f281" providerId="LiveId" clId="{AB3AD8FA-EAF4-40B3-BC33-1A83D204ECFD}" dt="2023-12-22T01:43:46.770" v="1" actId="478"/>
          <ac:picMkLst>
            <pc:docMk/>
            <pc:sldMk cId="1037682986" sldId="257"/>
            <ac:picMk id="12" creationId="{FFC92689-9EAA-B81E-58F4-5D3F2122EF37}"/>
          </ac:picMkLst>
        </pc:picChg>
        <pc:picChg chg="add mod">
          <ac:chgData name="Kyuwoong Kim" userId="c6581f603476f281" providerId="LiveId" clId="{AB3AD8FA-EAF4-40B3-BC33-1A83D204ECFD}" dt="2023-12-22T02:08:51.164" v="288" actId="1076"/>
          <ac:picMkLst>
            <pc:docMk/>
            <pc:sldMk cId="1037682986" sldId="257"/>
            <ac:picMk id="13" creationId="{B53CCBB4-0B80-D41A-BC82-1969AE576977}"/>
          </ac:picMkLst>
        </pc:picChg>
        <pc:picChg chg="add mod">
          <ac:chgData name="Kyuwoong Kim" userId="c6581f603476f281" providerId="LiveId" clId="{AB3AD8FA-EAF4-40B3-BC33-1A83D204ECFD}" dt="2023-12-22T02:08:51.164" v="288" actId="1076"/>
          <ac:picMkLst>
            <pc:docMk/>
            <pc:sldMk cId="1037682986" sldId="257"/>
            <ac:picMk id="14" creationId="{9B354F50-063D-9DB5-9BDE-88FD7F5DC280}"/>
          </ac:picMkLst>
        </pc:picChg>
      </pc:sldChg>
    </pc:docChg>
  </pc:docChgLst>
  <pc:docChgLst>
    <pc:chgData name="Kyuwoong Kim" userId="c6581f603476f281" providerId="LiveId" clId="{7195441E-49BE-4972-85CA-C0E1F969063C}"/>
    <pc:docChg chg="undo custSel modSld">
      <pc:chgData name="Kyuwoong Kim" userId="c6581f603476f281" providerId="LiveId" clId="{7195441E-49BE-4972-85CA-C0E1F969063C}" dt="2023-12-27T04:49:16.474" v="57" actId="20577"/>
      <pc:docMkLst>
        <pc:docMk/>
      </pc:docMkLst>
      <pc:sldChg chg="addSp delSp modSp mod">
        <pc:chgData name="Kyuwoong Kim" userId="c6581f603476f281" providerId="LiveId" clId="{7195441E-49BE-4972-85CA-C0E1F969063C}" dt="2023-12-27T04:49:16.474" v="57" actId="20577"/>
        <pc:sldMkLst>
          <pc:docMk/>
          <pc:sldMk cId="1037682986" sldId="257"/>
        </pc:sldMkLst>
        <pc:spChg chg="mod">
          <ac:chgData name="Kyuwoong Kim" userId="c6581f603476f281" providerId="LiveId" clId="{7195441E-49BE-4972-85CA-C0E1F969063C}" dt="2023-12-27T04:49:16.474" v="57" actId="20577"/>
          <ac:spMkLst>
            <pc:docMk/>
            <pc:sldMk cId="1037682986" sldId="257"/>
            <ac:spMk id="12" creationId="{D9CF38EF-56BB-5B5F-9603-974CFEE48FEC}"/>
          </ac:spMkLst>
        </pc:spChg>
        <pc:spChg chg="mod">
          <ac:chgData name="Kyuwoong Kim" userId="c6581f603476f281" providerId="LiveId" clId="{7195441E-49BE-4972-85CA-C0E1F969063C}" dt="2023-12-27T01:35:57.991" v="40" actId="1076"/>
          <ac:spMkLst>
            <pc:docMk/>
            <pc:sldMk cId="1037682986" sldId="257"/>
            <ac:spMk id="21" creationId="{12112411-3BB9-15BD-96F2-4DFAD9EE62C8}"/>
          </ac:spMkLst>
        </pc:spChg>
        <pc:spChg chg="mod">
          <ac:chgData name="Kyuwoong Kim" userId="c6581f603476f281" providerId="LiveId" clId="{7195441E-49BE-4972-85CA-C0E1F969063C}" dt="2023-12-27T01:35:12.287" v="28" actId="1076"/>
          <ac:spMkLst>
            <pc:docMk/>
            <pc:sldMk cId="1037682986" sldId="257"/>
            <ac:spMk id="35" creationId="{70AB1660-B3CE-77D2-5D8C-D8408DC702D9}"/>
          </ac:spMkLst>
        </pc:spChg>
        <pc:spChg chg="mod">
          <ac:chgData name="Kyuwoong Kim" userId="c6581f603476f281" providerId="LiveId" clId="{7195441E-49BE-4972-85CA-C0E1F969063C}" dt="2023-12-27T01:36:18.515" v="45" actId="1076"/>
          <ac:spMkLst>
            <pc:docMk/>
            <pc:sldMk cId="1037682986" sldId="257"/>
            <ac:spMk id="38" creationId="{75830CAC-6B12-E0E8-422D-B6C9400A1632}"/>
          </ac:spMkLst>
        </pc:spChg>
        <pc:spChg chg="mod">
          <ac:chgData name="Kyuwoong Kim" userId="c6581f603476f281" providerId="LiveId" clId="{7195441E-49BE-4972-85CA-C0E1F969063C}" dt="2023-12-27T01:35:15.468" v="29" actId="1076"/>
          <ac:spMkLst>
            <pc:docMk/>
            <pc:sldMk cId="1037682986" sldId="257"/>
            <ac:spMk id="39" creationId="{59842221-111E-3077-4793-03A331493134}"/>
          </ac:spMkLst>
        </pc:spChg>
        <pc:spChg chg="mod">
          <ac:chgData name="Kyuwoong Kim" userId="c6581f603476f281" providerId="LiveId" clId="{7195441E-49BE-4972-85CA-C0E1F969063C}" dt="2023-12-27T01:36:33.464" v="50" actId="1076"/>
          <ac:spMkLst>
            <pc:docMk/>
            <pc:sldMk cId="1037682986" sldId="257"/>
            <ac:spMk id="40" creationId="{E1EB41B9-F25F-6955-8F1D-4E3E210433FC}"/>
          </ac:spMkLst>
        </pc:spChg>
        <pc:spChg chg="mod">
          <ac:chgData name="Kyuwoong Kim" userId="c6581f603476f281" providerId="LiveId" clId="{7195441E-49BE-4972-85CA-C0E1F969063C}" dt="2023-12-27T01:35:32.571" v="32" actId="1076"/>
          <ac:spMkLst>
            <pc:docMk/>
            <pc:sldMk cId="1037682986" sldId="257"/>
            <ac:spMk id="41" creationId="{681649CF-8F1A-BE31-7BC6-0C48E9FF9B97}"/>
          </ac:spMkLst>
        </pc:spChg>
        <pc:spChg chg="mod">
          <ac:chgData name="Kyuwoong Kim" userId="c6581f603476f281" providerId="LiveId" clId="{7195441E-49BE-4972-85CA-C0E1F969063C}" dt="2023-12-27T01:35:49.767" v="36" actId="1076"/>
          <ac:spMkLst>
            <pc:docMk/>
            <pc:sldMk cId="1037682986" sldId="257"/>
            <ac:spMk id="48" creationId="{622735BE-5519-093A-F7CB-E3D635556409}"/>
          </ac:spMkLst>
        </pc:spChg>
        <pc:spChg chg="mod">
          <ac:chgData name="Kyuwoong Kim" userId="c6581f603476f281" providerId="LiveId" clId="{7195441E-49BE-4972-85CA-C0E1F969063C}" dt="2023-12-27T01:35:52.220" v="37" actId="1076"/>
          <ac:spMkLst>
            <pc:docMk/>
            <pc:sldMk cId="1037682986" sldId="257"/>
            <ac:spMk id="49" creationId="{B0515DB5-2198-0BD1-261B-331C1CC43A0F}"/>
          </ac:spMkLst>
        </pc:spChg>
        <pc:spChg chg="mod">
          <ac:chgData name="Kyuwoong Kim" userId="c6581f603476f281" providerId="LiveId" clId="{7195441E-49BE-4972-85CA-C0E1F969063C}" dt="2023-12-27T01:36:01.765" v="41" actId="1076"/>
          <ac:spMkLst>
            <pc:docMk/>
            <pc:sldMk cId="1037682986" sldId="257"/>
            <ac:spMk id="50" creationId="{28E6E8D2-F0CF-7635-08AB-13818695D9FD}"/>
          </ac:spMkLst>
        </pc:spChg>
        <pc:spChg chg="mod">
          <ac:chgData name="Kyuwoong Kim" userId="c6581f603476f281" providerId="LiveId" clId="{7195441E-49BE-4972-85CA-C0E1F969063C}" dt="2023-12-27T01:36:04.284" v="42" actId="1076"/>
          <ac:spMkLst>
            <pc:docMk/>
            <pc:sldMk cId="1037682986" sldId="257"/>
            <ac:spMk id="51" creationId="{58E86152-40C0-3EC5-B47C-887EC496857E}"/>
          </ac:spMkLst>
        </pc:spChg>
        <pc:spChg chg="mod">
          <ac:chgData name="Kyuwoong Kim" userId="c6581f603476f281" providerId="LiveId" clId="{7195441E-49BE-4972-85CA-C0E1F969063C}" dt="2023-12-27T01:36:27.560" v="48" actId="1076"/>
          <ac:spMkLst>
            <pc:docMk/>
            <pc:sldMk cId="1037682986" sldId="257"/>
            <ac:spMk id="53" creationId="{2A47FEAD-69CC-726F-A02C-A9A4AC48BC06}"/>
          </ac:spMkLst>
        </pc:spChg>
        <pc:spChg chg="mod">
          <ac:chgData name="Kyuwoong Kim" userId="c6581f603476f281" providerId="LiveId" clId="{7195441E-49BE-4972-85CA-C0E1F969063C}" dt="2023-12-27T01:34:58.522" v="24" actId="1076"/>
          <ac:spMkLst>
            <pc:docMk/>
            <pc:sldMk cId="1037682986" sldId="257"/>
            <ac:spMk id="56" creationId="{A8E53E1A-EAD9-987A-69DE-A3539E8F3A24}"/>
          </ac:spMkLst>
        </pc:spChg>
        <pc:spChg chg="mod">
          <ac:chgData name="Kyuwoong Kim" userId="c6581f603476f281" providerId="LiveId" clId="{7195441E-49BE-4972-85CA-C0E1F969063C}" dt="2023-12-27T01:34:58.522" v="24" actId="1076"/>
          <ac:spMkLst>
            <pc:docMk/>
            <pc:sldMk cId="1037682986" sldId="257"/>
            <ac:spMk id="57" creationId="{D8599CB8-A876-D470-D910-AF42CADEE583}"/>
          </ac:spMkLst>
        </pc:spChg>
        <pc:picChg chg="del">
          <ac:chgData name="Kyuwoong Kim" userId="c6581f603476f281" providerId="LiveId" clId="{7195441E-49BE-4972-85CA-C0E1F969063C}" dt="2023-12-27T01:29:19.201" v="15" actId="478"/>
          <ac:picMkLst>
            <pc:docMk/>
            <pc:sldMk cId="1037682986" sldId="257"/>
            <ac:picMk id="2" creationId="{89F1FC39-C451-D940-77C3-EB949E3015FC}"/>
          </ac:picMkLst>
        </pc:picChg>
        <pc:picChg chg="add mod ord">
          <ac:chgData name="Kyuwoong Kim" userId="c6581f603476f281" providerId="LiveId" clId="{7195441E-49BE-4972-85CA-C0E1F969063C}" dt="2023-12-27T01:36:29.244" v="49" actId="14100"/>
          <ac:picMkLst>
            <pc:docMk/>
            <pc:sldMk cId="1037682986" sldId="257"/>
            <ac:picMk id="3" creationId="{0271AFDF-13F3-CE74-DF5E-735756FE86E3}"/>
          </ac:picMkLst>
        </pc:picChg>
        <pc:picChg chg="del">
          <ac:chgData name="Kyuwoong Kim" userId="c6581f603476f281" providerId="LiveId" clId="{7195441E-49BE-4972-85CA-C0E1F969063C}" dt="2023-12-27T01:29:18.832" v="14" actId="478"/>
          <ac:picMkLst>
            <pc:docMk/>
            <pc:sldMk cId="1037682986" sldId="257"/>
            <ac:picMk id="4" creationId="{78CFC0BB-A8AA-3A99-B3A4-0F096EF75EF2}"/>
          </ac:picMkLst>
        </pc:picChg>
        <pc:picChg chg="del">
          <ac:chgData name="Kyuwoong Kim" userId="c6581f603476f281" providerId="LiveId" clId="{7195441E-49BE-4972-85CA-C0E1F969063C}" dt="2023-12-27T01:29:18.473" v="13" actId="478"/>
          <ac:picMkLst>
            <pc:docMk/>
            <pc:sldMk cId="1037682986" sldId="257"/>
            <ac:picMk id="5" creationId="{B7846E34-7695-90B4-ED71-8D35E87029BD}"/>
          </ac:picMkLst>
        </pc:picChg>
        <pc:picChg chg="del">
          <ac:chgData name="Kyuwoong Kim" userId="c6581f603476f281" providerId="LiveId" clId="{7195441E-49BE-4972-85CA-C0E1F969063C}" dt="2023-12-27T01:29:17.960" v="12" actId="478"/>
          <ac:picMkLst>
            <pc:docMk/>
            <pc:sldMk cId="1037682986" sldId="257"/>
            <ac:picMk id="6" creationId="{05B99E67-0C4F-310E-2828-FDAFE392684F}"/>
          </ac:picMkLst>
        </pc:picChg>
        <pc:picChg chg="add mod ord">
          <ac:chgData name="Kyuwoong Kim" userId="c6581f603476f281" providerId="LiveId" clId="{7195441E-49BE-4972-85CA-C0E1F969063C}" dt="2023-12-27T01:36:06.841" v="43" actId="14100"/>
          <ac:picMkLst>
            <pc:docMk/>
            <pc:sldMk cId="1037682986" sldId="257"/>
            <ac:picMk id="7" creationId="{66A0C3B0-F724-2B56-6783-34B9E6228847}"/>
          </ac:picMkLst>
        </pc:picChg>
        <pc:picChg chg="add mod ord">
          <ac:chgData name="Kyuwoong Kim" userId="c6581f603476f281" providerId="LiveId" clId="{7195441E-49BE-4972-85CA-C0E1F969063C}" dt="2023-12-27T01:36:11.348" v="44" actId="14100"/>
          <ac:picMkLst>
            <pc:docMk/>
            <pc:sldMk cId="1037682986" sldId="257"/>
            <ac:picMk id="8" creationId="{4F179E6F-6ACC-0602-D67B-C0F5BE897127}"/>
          </ac:picMkLst>
        </pc:picChg>
        <pc:picChg chg="add mod ord">
          <ac:chgData name="Kyuwoong Kim" userId="c6581f603476f281" providerId="LiveId" clId="{7195441E-49BE-4972-85CA-C0E1F969063C}" dt="2023-12-27T01:35:37.864" v="34" actId="1076"/>
          <ac:picMkLst>
            <pc:docMk/>
            <pc:sldMk cId="1037682986" sldId="257"/>
            <ac:picMk id="9" creationId="{B98C3D19-0232-E445-9BB5-5216B5121A45}"/>
          </ac:picMkLst>
        </pc:picChg>
        <pc:picChg chg="del">
          <ac:chgData name="Kyuwoong Kim" userId="c6581f603476f281" providerId="LiveId" clId="{7195441E-49BE-4972-85CA-C0E1F969063C}" dt="2023-12-27T01:29:17.634" v="11" actId="478"/>
          <ac:picMkLst>
            <pc:docMk/>
            <pc:sldMk cId="1037682986" sldId="257"/>
            <ac:picMk id="10" creationId="{184CEB08-BB23-794B-AD8A-86F485ED0A75}"/>
          </ac:picMkLst>
        </pc:picChg>
        <pc:picChg chg="del">
          <ac:chgData name="Kyuwoong Kim" userId="c6581f603476f281" providerId="LiveId" clId="{7195441E-49BE-4972-85CA-C0E1F969063C}" dt="2023-12-27T01:29:17.039" v="10" actId="478"/>
          <ac:picMkLst>
            <pc:docMk/>
            <pc:sldMk cId="1037682986" sldId="257"/>
            <ac:picMk id="11" creationId="{0D3255E8-C6D7-5AB4-41DB-A9E9AED6C338}"/>
          </ac:picMkLst>
        </pc:picChg>
        <pc:picChg chg="add mod ord">
          <ac:chgData name="Kyuwoong Kim" userId="c6581f603476f281" providerId="LiveId" clId="{7195441E-49BE-4972-85CA-C0E1F969063C}" dt="2023-12-27T01:35:22.681" v="31" actId="14100"/>
          <ac:picMkLst>
            <pc:docMk/>
            <pc:sldMk cId="1037682986" sldId="257"/>
            <ac:picMk id="13" creationId="{2EEFA841-361A-C35E-7D68-204242CFEA49}"/>
          </ac:picMkLst>
        </pc:picChg>
        <pc:picChg chg="add mod ord">
          <ac:chgData name="Kyuwoong Kim" userId="c6581f603476f281" providerId="LiveId" clId="{7195441E-49BE-4972-85CA-C0E1F969063C}" dt="2023-12-27T01:35:04.468" v="26" actId="14100"/>
          <ac:picMkLst>
            <pc:docMk/>
            <pc:sldMk cId="1037682986" sldId="257"/>
            <ac:picMk id="14" creationId="{8D85575E-A2BC-A34E-EB1C-ADCF1AC9950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44999" y="1355149"/>
            <a:ext cx="10709990" cy="2882806"/>
          </a:xfrm>
        </p:spPr>
        <p:txBody>
          <a:bodyPr anchor="b"/>
          <a:lstStyle>
            <a:lvl1pPr algn="ctr">
              <a:defRPr sz="724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74999" y="4349128"/>
            <a:ext cx="9449991" cy="1999179"/>
          </a:xfrm>
        </p:spPr>
        <p:txBody>
          <a:bodyPr/>
          <a:lstStyle>
            <a:lvl1pPr marL="0" indent="0" algn="ctr">
              <a:buNone/>
              <a:defRPr sz="2898"/>
            </a:lvl1pPr>
            <a:lvl2pPr marL="552023" indent="0" algn="ctr">
              <a:buNone/>
              <a:defRPr sz="2415"/>
            </a:lvl2pPr>
            <a:lvl3pPr marL="1104047" indent="0" algn="ctr">
              <a:buNone/>
              <a:defRPr sz="2173"/>
            </a:lvl3pPr>
            <a:lvl4pPr marL="1656070" indent="0" algn="ctr">
              <a:buNone/>
              <a:defRPr sz="1932"/>
            </a:lvl4pPr>
            <a:lvl5pPr marL="2208093" indent="0" algn="ctr">
              <a:buNone/>
              <a:defRPr sz="1932"/>
            </a:lvl5pPr>
            <a:lvl6pPr marL="2760116" indent="0" algn="ctr">
              <a:buNone/>
              <a:defRPr sz="1932"/>
            </a:lvl6pPr>
            <a:lvl7pPr marL="3312140" indent="0" algn="ctr">
              <a:buNone/>
              <a:defRPr sz="1932"/>
            </a:lvl7pPr>
            <a:lvl8pPr marL="3864163" indent="0" algn="ctr">
              <a:buNone/>
              <a:defRPr sz="1932"/>
            </a:lvl8pPr>
            <a:lvl9pPr marL="4416186" indent="0" algn="ctr">
              <a:buNone/>
              <a:defRPr sz="1932"/>
            </a:lvl9pPr>
          </a:lstStyle>
          <a:p>
            <a:r>
              <a:rPr lang="ko-KR" altLang="en-US"/>
              <a:t>클릭하여 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764153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4288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016867" y="440855"/>
            <a:ext cx="2716872" cy="7017256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66250" y="440855"/>
            <a:ext cx="7993117" cy="7017256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403571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96158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59687" y="2064352"/>
            <a:ext cx="10867490" cy="3444416"/>
          </a:xfrm>
        </p:spPr>
        <p:txBody>
          <a:bodyPr anchor="b"/>
          <a:lstStyle>
            <a:lvl1pPr>
              <a:defRPr sz="724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59687" y="5541353"/>
            <a:ext cx="10867490" cy="1811337"/>
          </a:xfrm>
        </p:spPr>
        <p:txBody>
          <a:bodyPr/>
          <a:lstStyle>
            <a:lvl1pPr marL="0" indent="0">
              <a:buNone/>
              <a:defRPr sz="2898">
                <a:solidFill>
                  <a:schemeClr val="tx1"/>
                </a:solidFill>
              </a:defRPr>
            </a:lvl1pPr>
            <a:lvl2pPr marL="552023" indent="0">
              <a:buNone/>
              <a:defRPr sz="2415">
                <a:solidFill>
                  <a:schemeClr val="tx1">
                    <a:tint val="75000"/>
                  </a:schemeClr>
                </a:solidFill>
              </a:defRPr>
            </a:lvl2pPr>
            <a:lvl3pPr marL="1104047" indent="0">
              <a:buNone/>
              <a:defRPr sz="2173">
                <a:solidFill>
                  <a:schemeClr val="tx1">
                    <a:tint val="75000"/>
                  </a:schemeClr>
                </a:solidFill>
              </a:defRPr>
            </a:lvl3pPr>
            <a:lvl4pPr marL="1656070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4pPr>
            <a:lvl5pPr marL="2208093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5pPr>
            <a:lvl6pPr marL="2760116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6pPr>
            <a:lvl7pPr marL="3312140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7pPr>
            <a:lvl8pPr marL="3864163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8pPr>
            <a:lvl9pPr marL="4416186" indent="0">
              <a:buNone/>
              <a:defRPr sz="1932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3881764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66249" y="2204273"/>
            <a:ext cx="5354995" cy="52538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378744" y="2204273"/>
            <a:ext cx="5354995" cy="5253838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9651673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440856"/>
            <a:ext cx="10867490" cy="160049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7892" y="2029849"/>
            <a:ext cx="5330385" cy="994797"/>
          </a:xfrm>
        </p:spPr>
        <p:txBody>
          <a:bodyPr anchor="b"/>
          <a:lstStyle>
            <a:lvl1pPr marL="0" indent="0">
              <a:buNone/>
              <a:defRPr sz="2898" b="1"/>
            </a:lvl1pPr>
            <a:lvl2pPr marL="552023" indent="0">
              <a:buNone/>
              <a:defRPr sz="2415" b="1"/>
            </a:lvl2pPr>
            <a:lvl3pPr marL="1104047" indent="0">
              <a:buNone/>
              <a:defRPr sz="2173" b="1"/>
            </a:lvl3pPr>
            <a:lvl4pPr marL="1656070" indent="0">
              <a:buNone/>
              <a:defRPr sz="1932" b="1"/>
            </a:lvl4pPr>
            <a:lvl5pPr marL="2208093" indent="0">
              <a:buNone/>
              <a:defRPr sz="1932" b="1"/>
            </a:lvl5pPr>
            <a:lvl6pPr marL="2760116" indent="0">
              <a:buNone/>
              <a:defRPr sz="1932" b="1"/>
            </a:lvl6pPr>
            <a:lvl7pPr marL="3312140" indent="0">
              <a:buNone/>
              <a:defRPr sz="1932" b="1"/>
            </a:lvl7pPr>
            <a:lvl8pPr marL="3864163" indent="0">
              <a:buNone/>
              <a:defRPr sz="1932" b="1"/>
            </a:lvl8pPr>
            <a:lvl9pPr marL="4416186" indent="0">
              <a:buNone/>
              <a:defRPr sz="1932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67892" y="3024646"/>
            <a:ext cx="5330385" cy="444879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378745" y="2029849"/>
            <a:ext cx="5356636" cy="994797"/>
          </a:xfrm>
        </p:spPr>
        <p:txBody>
          <a:bodyPr anchor="b"/>
          <a:lstStyle>
            <a:lvl1pPr marL="0" indent="0">
              <a:buNone/>
              <a:defRPr sz="2898" b="1"/>
            </a:lvl1pPr>
            <a:lvl2pPr marL="552023" indent="0">
              <a:buNone/>
              <a:defRPr sz="2415" b="1"/>
            </a:lvl2pPr>
            <a:lvl3pPr marL="1104047" indent="0">
              <a:buNone/>
              <a:defRPr sz="2173" b="1"/>
            </a:lvl3pPr>
            <a:lvl4pPr marL="1656070" indent="0">
              <a:buNone/>
              <a:defRPr sz="1932" b="1"/>
            </a:lvl4pPr>
            <a:lvl5pPr marL="2208093" indent="0">
              <a:buNone/>
              <a:defRPr sz="1932" b="1"/>
            </a:lvl5pPr>
            <a:lvl6pPr marL="2760116" indent="0">
              <a:buNone/>
              <a:defRPr sz="1932" b="1"/>
            </a:lvl6pPr>
            <a:lvl7pPr marL="3312140" indent="0">
              <a:buNone/>
              <a:defRPr sz="1932" b="1"/>
            </a:lvl7pPr>
            <a:lvl8pPr marL="3864163" indent="0">
              <a:buNone/>
              <a:defRPr sz="1932" b="1"/>
            </a:lvl8pPr>
            <a:lvl9pPr marL="4416186" indent="0">
              <a:buNone/>
              <a:defRPr sz="1932" b="1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378745" y="3024646"/>
            <a:ext cx="5356636" cy="4448799"/>
          </a:xfrm>
        </p:spPr>
        <p:txBody>
          <a:bodyPr/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681006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288885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9395272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52027"/>
            <a:ext cx="4063824" cy="1932093"/>
          </a:xfrm>
        </p:spPr>
        <p:txBody>
          <a:bodyPr anchor="b"/>
          <a:lstStyle>
            <a:lvl1pPr>
              <a:defRPr sz="386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356636" y="1192226"/>
            <a:ext cx="6378744" cy="5884451"/>
          </a:xfrm>
        </p:spPr>
        <p:txBody>
          <a:bodyPr/>
          <a:lstStyle>
            <a:lvl1pPr>
              <a:defRPr sz="3864"/>
            </a:lvl1pPr>
            <a:lvl2pPr>
              <a:defRPr sz="3381"/>
            </a:lvl2pPr>
            <a:lvl3pPr>
              <a:defRPr sz="2898"/>
            </a:lvl3pPr>
            <a:lvl4pPr>
              <a:defRPr sz="2415"/>
            </a:lvl4pPr>
            <a:lvl5pPr>
              <a:defRPr sz="2415"/>
            </a:lvl5pPr>
            <a:lvl6pPr>
              <a:defRPr sz="2415"/>
            </a:lvl6pPr>
            <a:lvl7pPr>
              <a:defRPr sz="2415"/>
            </a:lvl7pPr>
            <a:lvl8pPr>
              <a:defRPr sz="2415"/>
            </a:lvl8pPr>
            <a:lvl9pPr>
              <a:defRPr sz="2415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484120"/>
            <a:ext cx="4063824" cy="4602140"/>
          </a:xfrm>
        </p:spPr>
        <p:txBody>
          <a:bodyPr/>
          <a:lstStyle>
            <a:lvl1pPr marL="0" indent="0">
              <a:buNone/>
              <a:defRPr sz="1932"/>
            </a:lvl1pPr>
            <a:lvl2pPr marL="552023" indent="0">
              <a:buNone/>
              <a:defRPr sz="1690"/>
            </a:lvl2pPr>
            <a:lvl3pPr marL="1104047" indent="0">
              <a:buNone/>
              <a:defRPr sz="1449"/>
            </a:lvl3pPr>
            <a:lvl4pPr marL="1656070" indent="0">
              <a:buNone/>
              <a:defRPr sz="1207"/>
            </a:lvl4pPr>
            <a:lvl5pPr marL="2208093" indent="0">
              <a:buNone/>
              <a:defRPr sz="1207"/>
            </a:lvl5pPr>
            <a:lvl6pPr marL="2760116" indent="0">
              <a:buNone/>
              <a:defRPr sz="1207"/>
            </a:lvl6pPr>
            <a:lvl7pPr marL="3312140" indent="0">
              <a:buNone/>
              <a:defRPr sz="1207"/>
            </a:lvl7pPr>
            <a:lvl8pPr marL="3864163" indent="0">
              <a:buNone/>
              <a:defRPr sz="1207"/>
            </a:lvl8pPr>
            <a:lvl9pPr marL="4416186" indent="0">
              <a:buNone/>
              <a:defRPr sz="120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827773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67890" y="552027"/>
            <a:ext cx="4063824" cy="1932093"/>
          </a:xfrm>
        </p:spPr>
        <p:txBody>
          <a:bodyPr anchor="b"/>
          <a:lstStyle>
            <a:lvl1pPr>
              <a:defRPr sz="3864"/>
            </a:lvl1pPr>
          </a:lstStyle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356636" y="1192226"/>
            <a:ext cx="6378744" cy="5884451"/>
          </a:xfrm>
        </p:spPr>
        <p:txBody>
          <a:bodyPr anchor="t"/>
          <a:lstStyle>
            <a:lvl1pPr marL="0" indent="0">
              <a:buNone/>
              <a:defRPr sz="3864"/>
            </a:lvl1pPr>
            <a:lvl2pPr marL="552023" indent="0">
              <a:buNone/>
              <a:defRPr sz="3381"/>
            </a:lvl2pPr>
            <a:lvl3pPr marL="1104047" indent="0">
              <a:buNone/>
              <a:defRPr sz="2898"/>
            </a:lvl3pPr>
            <a:lvl4pPr marL="1656070" indent="0">
              <a:buNone/>
              <a:defRPr sz="2415"/>
            </a:lvl4pPr>
            <a:lvl5pPr marL="2208093" indent="0">
              <a:buNone/>
              <a:defRPr sz="2415"/>
            </a:lvl5pPr>
            <a:lvl6pPr marL="2760116" indent="0">
              <a:buNone/>
              <a:defRPr sz="2415"/>
            </a:lvl6pPr>
            <a:lvl7pPr marL="3312140" indent="0">
              <a:buNone/>
              <a:defRPr sz="2415"/>
            </a:lvl7pPr>
            <a:lvl8pPr marL="3864163" indent="0">
              <a:buNone/>
              <a:defRPr sz="2415"/>
            </a:lvl8pPr>
            <a:lvl9pPr marL="4416186" indent="0">
              <a:buNone/>
              <a:defRPr sz="2415"/>
            </a:lvl9pPr>
          </a:lstStyle>
          <a:p>
            <a:r>
              <a:rPr lang="ko-KR" altLang="en-US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67890" y="2484120"/>
            <a:ext cx="4063824" cy="4602140"/>
          </a:xfrm>
        </p:spPr>
        <p:txBody>
          <a:bodyPr/>
          <a:lstStyle>
            <a:lvl1pPr marL="0" indent="0">
              <a:buNone/>
              <a:defRPr sz="1932"/>
            </a:lvl1pPr>
            <a:lvl2pPr marL="552023" indent="0">
              <a:buNone/>
              <a:defRPr sz="1690"/>
            </a:lvl2pPr>
            <a:lvl3pPr marL="1104047" indent="0">
              <a:buNone/>
              <a:defRPr sz="1449"/>
            </a:lvl3pPr>
            <a:lvl4pPr marL="1656070" indent="0">
              <a:buNone/>
              <a:defRPr sz="1207"/>
            </a:lvl4pPr>
            <a:lvl5pPr marL="2208093" indent="0">
              <a:buNone/>
              <a:defRPr sz="1207"/>
            </a:lvl5pPr>
            <a:lvl6pPr marL="2760116" indent="0">
              <a:buNone/>
              <a:defRPr sz="1207"/>
            </a:lvl6pPr>
            <a:lvl7pPr marL="3312140" indent="0">
              <a:buNone/>
              <a:defRPr sz="1207"/>
            </a:lvl7pPr>
            <a:lvl8pPr marL="3864163" indent="0">
              <a:buNone/>
              <a:defRPr sz="1207"/>
            </a:lvl8pPr>
            <a:lvl9pPr marL="4416186" indent="0">
              <a:buNone/>
              <a:defRPr sz="1207"/>
            </a:lvl9pPr>
          </a:lstStyle>
          <a:p>
            <a:pPr lvl="0"/>
            <a:r>
              <a:rPr lang="ko-KR" altLang="en-US"/>
              <a:t>마스터 텍스트 스타일을 편집하려면 클릭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1267275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66249" y="440856"/>
            <a:ext cx="10867490" cy="1600495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66249" y="2204273"/>
            <a:ext cx="10867490" cy="52538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하려면 클릭</a:t>
            </a:r>
          </a:p>
          <a:p>
            <a:pPr lvl="1"/>
            <a:r>
              <a:rPr lang="ko-KR" altLang="en-US"/>
              <a:t>두 번째 수준</a:t>
            </a:r>
          </a:p>
          <a:p>
            <a:pPr lvl="2"/>
            <a:r>
              <a:rPr lang="ko-KR" altLang="en-US"/>
              <a:t>세 번째 수준</a:t>
            </a:r>
          </a:p>
          <a:p>
            <a:pPr lvl="3"/>
            <a:r>
              <a:rPr lang="ko-KR" altLang="en-US"/>
              <a:t>네 번째 수준</a:t>
            </a:r>
          </a:p>
          <a:p>
            <a:pPr lvl="4"/>
            <a:r>
              <a:rPr lang="ko-KR" altLang="en-US"/>
              <a:t>다섯 번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66249" y="7674706"/>
            <a:ext cx="283499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5BCB1A9-B30B-4879-B617-C578C999750E}" type="datetimeFigureOut">
              <a:rPr lang="ko-KR" altLang="en-US" smtClean="0"/>
              <a:t>2023-12-27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73746" y="7674706"/>
            <a:ext cx="4252496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898742" y="7674706"/>
            <a:ext cx="2834997" cy="44085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449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34D61A-29C0-488F-8C1E-44C0A90371CC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3678775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104047" rtl="0" eaLnBrk="1" latinLnBrk="1" hangingPunct="1">
        <a:lnSpc>
          <a:spcPct val="90000"/>
        </a:lnSpc>
        <a:spcBef>
          <a:spcPct val="0"/>
        </a:spcBef>
        <a:buNone/>
        <a:defRPr sz="531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76012" indent="-276012" algn="l" defTabSz="1104047" rtl="0" eaLnBrk="1" latinLnBrk="1" hangingPunct="1">
        <a:lnSpc>
          <a:spcPct val="90000"/>
        </a:lnSpc>
        <a:spcBef>
          <a:spcPts val="1207"/>
        </a:spcBef>
        <a:buFont typeface="Arial" panose="020B0604020202020204" pitchFamily="34" charset="0"/>
        <a:buChar char="•"/>
        <a:defRPr sz="3381" kern="1200">
          <a:solidFill>
            <a:schemeClr val="tx1"/>
          </a:solidFill>
          <a:latin typeface="+mn-lt"/>
          <a:ea typeface="+mn-ea"/>
          <a:cs typeface="+mn-cs"/>
        </a:defRPr>
      </a:lvl1pPr>
      <a:lvl2pPr marL="828035" indent="-276012" algn="l" defTabSz="1104047" rtl="0" eaLnBrk="1" latinLnBrk="1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898" kern="1200">
          <a:solidFill>
            <a:schemeClr val="tx1"/>
          </a:solidFill>
          <a:latin typeface="+mn-lt"/>
          <a:ea typeface="+mn-ea"/>
          <a:cs typeface="+mn-cs"/>
        </a:defRPr>
      </a:lvl2pPr>
      <a:lvl3pPr marL="1380058" indent="-276012" algn="l" defTabSz="1104047" rtl="0" eaLnBrk="1" latinLnBrk="1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415" kern="1200">
          <a:solidFill>
            <a:schemeClr val="tx1"/>
          </a:solidFill>
          <a:latin typeface="+mn-lt"/>
          <a:ea typeface="+mn-ea"/>
          <a:cs typeface="+mn-cs"/>
        </a:defRPr>
      </a:lvl3pPr>
      <a:lvl4pPr marL="1932081" indent="-276012" algn="l" defTabSz="1104047" rtl="0" eaLnBrk="1" latinLnBrk="1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4pPr>
      <a:lvl5pPr marL="2484105" indent="-276012" algn="l" defTabSz="1104047" rtl="0" eaLnBrk="1" latinLnBrk="1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5pPr>
      <a:lvl6pPr marL="3036128" indent="-276012" algn="l" defTabSz="1104047" rtl="0" eaLnBrk="1" latinLnBrk="1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6pPr>
      <a:lvl7pPr marL="3588151" indent="-276012" algn="l" defTabSz="1104047" rtl="0" eaLnBrk="1" latinLnBrk="1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7pPr>
      <a:lvl8pPr marL="4140175" indent="-276012" algn="l" defTabSz="1104047" rtl="0" eaLnBrk="1" latinLnBrk="1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8pPr>
      <a:lvl9pPr marL="4692198" indent="-276012" algn="l" defTabSz="1104047" rtl="0" eaLnBrk="1" latinLnBrk="1" hangingPunct="1">
        <a:lnSpc>
          <a:spcPct val="90000"/>
        </a:lnSpc>
        <a:spcBef>
          <a:spcPts val="604"/>
        </a:spcBef>
        <a:buFont typeface="Arial" panose="020B0604020202020204" pitchFamily="34" charset="0"/>
        <a:buChar char="•"/>
        <a:defRPr sz="217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104047" rtl="0" eaLnBrk="1" latinLnBrk="1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1pPr>
      <a:lvl2pPr marL="552023" algn="l" defTabSz="1104047" rtl="0" eaLnBrk="1" latinLnBrk="1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2pPr>
      <a:lvl3pPr marL="1104047" algn="l" defTabSz="1104047" rtl="0" eaLnBrk="1" latinLnBrk="1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3pPr>
      <a:lvl4pPr marL="1656070" algn="l" defTabSz="1104047" rtl="0" eaLnBrk="1" latinLnBrk="1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4pPr>
      <a:lvl5pPr marL="2208093" algn="l" defTabSz="1104047" rtl="0" eaLnBrk="1" latinLnBrk="1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5pPr>
      <a:lvl6pPr marL="2760116" algn="l" defTabSz="1104047" rtl="0" eaLnBrk="1" latinLnBrk="1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6pPr>
      <a:lvl7pPr marL="3312140" algn="l" defTabSz="1104047" rtl="0" eaLnBrk="1" latinLnBrk="1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7pPr>
      <a:lvl8pPr marL="3864163" algn="l" defTabSz="1104047" rtl="0" eaLnBrk="1" latinLnBrk="1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8pPr>
      <a:lvl9pPr marL="4416186" algn="l" defTabSz="1104047" rtl="0" eaLnBrk="1" latinLnBrk="1" hangingPunct="1">
        <a:defRPr sz="217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그림 2" descr="텍스트, 스크린샷, 도표, 직사각형이(가) 표시된 사진&#10;&#10;자동 생성된 설명">
            <a:extLst>
              <a:ext uri="{FF2B5EF4-FFF2-40B4-BE49-F238E27FC236}">
                <a16:creationId xmlns:a16="http://schemas.microsoft.com/office/drawing/2014/main" id="{0271AFDF-13F3-CE74-DF5E-735756FE86E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85306" y="4639214"/>
            <a:ext cx="3433139" cy="3035035"/>
          </a:xfrm>
          <a:prstGeom prst="rect">
            <a:avLst/>
          </a:prstGeom>
        </p:spPr>
      </p:pic>
      <p:pic>
        <p:nvPicPr>
          <p:cNvPr id="7" name="그림 6" descr="텍스트, 도표, 스크린샷, 라인이(가) 표시된 사진&#10;&#10;자동 생성된 설명">
            <a:extLst>
              <a:ext uri="{FF2B5EF4-FFF2-40B4-BE49-F238E27FC236}">
                <a16:creationId xmlns:a16="http://schemas.microsoft.com/office/drawing/2014/main" id="{66A0C3B0-F724-2B56-6783-34B9E6228847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6020" y="4659471"/>
            <a:ext cx="3629506" cy="3035036"/>
          </a:xfrm>
          <a:prstGeom prst="rect">
            <a:avLst/>
          </a:prstGeom>
        </p:spPr>
      </p:pic>
      <p:pic>
        <p:nvPicPr>
          <p:cNvPr id="8" name="그림 7" descr="텍스트, 스크린샷, 도표, 직사각형이(가) 표시된 사진&#10;&#10;자동 생성된 설명">
            <a:extLst>
              <a:ext uri="{FF2B5EF4-FFF2-40B4-BE49-F238E27FC236}">
                <a16:creationId xmlns:a16="http://schemas.microsoft.com/office/drawing/2014/main" id="{4F179E6F-6ACC-0602-D67B-C0F5BE897127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313" y="4555097"/>
            <a:ext cx="3511761" cy="3139410"/>
          </a:xfrm>
          <a:prstGeom prst="rect">
            <a:avLst/>
          </a:prstGeom>
        </p:spPr>
      </p:pic>
      <p:pic>
        <p:nvPicPr>
          <p:cNvPr id="9" name="그림 8" descr="텍스트, 도표, 스크린샷, 직사각형이(가) 표시된 사진&#10;&#10;자동 생성된 설명">
            <a:extLst>
              <a:ext uri="{FF2B5EF4-FFF2-40B4-BE49-F238E27FC236}">
                <a16:creationId xmlns:a16="http://schemas.microsoft.com/office/drawing/2014/main" id="{B98C3D19-0232-E445-9BB5-5216B5121A45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576764" y="1266613"/>
            <a:ext cx="3600000" cy="3288484"/>
          </a:xfrm>
          <a:prstGeom prst="rect">
            <a:avLst/>
          </a:prstGeom>
        </p:spPr>
      </p:pic>
      <p:pic>
        <p:nvPicPr>
          <p:cNvPr id="13" name="그림 12" descr="텍스트, 도표, 스크린샷, 라인이(가) 표시된 사진&#10;&#10;자동 생성된 설명">
            <a:extLst>
              <a:ext uri="{FF2B5EF4-FFF2-40B4-BE49-F238E27FC236}">
                <a16:creationId xmlns:a16="http://schemas.microsoft.com/office/drawing/2014/main" id="{2EEFA841-361A-C35E-7D68-204242CFEA49}"/>
              </a:ext>
            </a:extLst>
          </p:cNvPr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734977" y="1266613"/>
            <a:ext cx="3546000" cy="3227813"/>
          </a:xfrm>
          <a:prstGeom prst="rect">
            <a:avLst/>
          </a:prstGeom>
        </p:spPr>
      </p:pic>
      <p:pic>
        <p:nvPicPr>
          <p:cNvPr id="14" name="그림 13" descr="텍스트, 스크린샷, 도표, 직사각형이(가) 표시된 사진&#10;&#10;자동 생성된 설명">
            <a:extLst>
              <a:ext uri="{FF2B5EF4-FFF2-40B4-BE49-F238E27FC236}">
                <a16:creationId xmlns:a16="http://schemas.microsoft.com/office/drawing/2014/main" id="{8D85575E-A2BC-A34E-EB1C-ADCF1AC99509}"/>
              </a:ext>
            </a:extLst>
          </p:cNvPr>
          <p:cNvPicPr preferRelativeResize="0"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11313" y="1345080"/>
            <a:ext cx="3546000" cy="3164606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0110422B-A330-DB43-E93C-5DF9FB920B6B}"/>
              </a:ext>
            </a:extLst>
          </p:cNvPr>
          <p:cNvSpPr txBox="1"/>
          <p:nvPr/>
        </p:nvSpPr>
        <p:spPr>
          <a:xfrm>
            <a:off x="833515" y="1359983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28600" indent="-228600">
              <a:buAutoNum type="alphaUcParenBoth"/>
            </a:pPr>
            <a:r>
              <a:rPr lang="en-US" altLang="ko-KR" sz="1200" b="1" dirty="0"/>
              <a:t>All</a:t>
            </a: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F7621210-4DEB-DC03-123C-1F7219027A33}"/>
              </a:ext>
            </a:extLst>
          </p:cNvPr>
          <p:cNvSpPr txBox="1"/>
          <p:nvPr/>
        </p:nvSpPr>
        <p:spPr>
          <a:xfrm rot="16200000">
            <a:off x="3925714" y="5570816"/>
            <a:ext cx="133428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Lean body mass</a:t>
            </a:r>
            <a:endParaRPr lang="ko-KR" altLang="en-US" sz="1200" dirty="0"/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0F4EDBFB-743C-9551-9B31-900B8968843C}"/>
              </a:ext>
            </a:extLst>
          </p:cNvPr>
          <p:cNvSpPr txBox="1"/>
          <p:nvPr/>
        </p:nvSpPr>
        <p:spPr>
          <a:xfrm rot="16200000">
            <a:off x="8118166" y="5570816"/>
            <a:ext cx="133428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Lean body mass</a:t>
            </a:r>
            <a:endParaRPr lang="ko-KR" altLang="en-US" sz="1200" dirty="0"/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70AB1660-B3CE-77D2-5D8C-D8408DC702D9}"/>
              </a:ext>
            </a:extLst>
          </p:cNvPr>
          <p:cNvSpPr txBox="1"/>
          <p:nvPr/>
        </p:nvSpPr>
        <p:spPr>
          <a:xfrm rot="16200000">
            <a:off x="-430904" y="2382361"/>
            <a:ext cx="1779757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Body fat mass (kg)</a:t>
            </a:r>
            <a:endParaRPr lang="ko-KR" altLang="en-US" sz="1000" dirty="0"/>
          </a:p>
        </p:txBody>
      </p:sp>
      <p:sp>
        <p:nvSpPr>
          <p:cNvPr id="36" name="TextBox 35">
            <a:extLst>
              <a:ext uri="{FF2B5EF4-FFF2-40B4-BE49-F238E27FC236}">
                <a16:creationId xmlns:a16="http://schemas.microsoft.com/office/drawing/2014/main" id="{41517E53-6946-C0A4-3CEB-705AB7147267}"/>
              </a:ext>
            </a:extLst>
          </p:cNvPr>
          <p:cNvSpPr txBox="1"/>
          <p:nvPr/>
        </p:nvSpPr>
        <p:spPr>
          <a:xfrm rot="16200000">
            <a:off x="3960248" y="2462723"/>
            <a:ext cx="133428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Body Fat mass</a:t>
            </a:r>
            <a:endParaRPr lang="ko-KR" altLang="en-US" sz="12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536D7B9A-9813-1BD4-26D6-5FCAFEC49DC0}"/>
              </a:ext>
            </a:extLst>
          </p:cNvPr>
          <p:cNvSpPr txBox="1"/>
          <p:nvPr/>
        </p:nvSpPr>
        <p:spPr>
          <a:xfrm rot="16200000">
            <a:off x="8162251" y="2462723"/>
            <a:ext cx="1334280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200" dirty="0"/>
              <a:t>Body Fat mass</a:t>
            </a:r>
            <a:endParaRPr lang="ko-KR" altLang="en-US" sz="12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75830CAC-6B12-E0E8-422D-B6C9400A1632}"/>
              </a:ext>
            </a:extLst>
          </p:cNvPr>
          <p:cNvSpPr txBox="1"/>
          <p:nvPr/>
        </p:nvSpPr>
        <p:spPr>
          <a:xfrm rot="16200000">
            <a:off x="3769190" y="5742729"/>
            <a:ext cx="166271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Lean body mass (kg)</a:t>
            </a:r>
            <a:endParaRPr lang="ko-KR" altLang="en-US" sz="105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59842221-111E-3077-4793-03A331493134}"/>
              </a:ext>
            </a:extLst>
          </p:cNvPr>
          <p:cNvSpPr txBox="1"/>
          <p:nvPr/>
        </p:nvSpPr>
        <p:spPr>
          <a:xfrm rot="16200000">
            <a:off x="3710671" y="2424885"/>
            <a:ext cx="177975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Body fat mass (kg)</a:t>
            </a:r>
            <a:endParaRPr lang="ko-KR" altLang="en-US" sz="105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1EB41B9-F25F-6955-8F1D-4E3E210433FC}"/>
              </a:ext>
            </a:extLst>
          </p:cNvPr>
          <p:cNvSpPr txBox="1"/>
          <p:nvPr/>
        </p:nvSpPr>
        <p:spPr>
          <a:xfrm rot="16200000">
            <a:off x="7961642" y="5794500"/>
            <a:ext cx="1662718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Lean body mass (kg)</a:t>
            </a:r>
            <a:endParaRPr lang="ko-KR" altLang="en-US" sz="105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EB886F77-C41C-CC57-767F-E8CFA9FF7E04}"/>
              </a:ext>
            </a:extLst>
          </p:cNvPr>
          <p:cNvSpPr txBox="1"/>
          <p:nvPr/>
        </p:nvSpPr>
        <p:spPr>
          <a:xfrm>
            <a:off x="4991610" y="1390491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(B) Men 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1B923759-EE7D-5F6F-083F-A2A6D42FF4E3}"/>
              </a:ext>
            </a:extLst>
          </p:cNvPr>
          <p:cNvSpPr txBox="1"/>
          <p:nvPr/>
        </p:nvSpPr>
        <p:spPr>
          <a:xfrm>
            <a:off x="9147611" y="1345121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(C) Women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E099F1B-C4B0-CB68-3D46-F97CB0D9FA0B}"/>
              </a:ext>
            </a:extLst>
          </p:cNvPr>
          <p:cNvSpPr txBox="1"/>
          <p:nvPr/>
        </p:nvSpPr>
        <p:spPr>
          <a:xfrm>
            <a:off x="842524" y="4471167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(D) All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266B1B07-D5D4-8078-C2BF-925F81997393}"/>
              </a:ext>
            </a:extLst>
          </p:cNvPr>
          <p:cNvSpPr txBox="1"/>
          <p:nvPr/>
        </p:nvSpPr>
        <p:spPr>
          <a:xfrm>
            <a:off x="4971017" y="4485797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(E) Men 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CFE6C89-8253-9163-0D05-478393A537F7}"/>
              </a:ext>
            </a:extLst>
          </p:cNvPr>
          <p:cNvSpPr txBox="1"/>
          <p:nvPr/>
        </p:nvSpPr>
        <p:spPr>
          <a:xfrm>
            <a:off x="9130886" y="4509685"/>
            <a:ext cx="35999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200" b="1" dirty="0"/>
              <a:t>(F) Women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622735BE-5519-093A-F7CB-E3D635556409}"/>
              </a:ext>
            </a:extLst>
          </p:cNvPr>
          <p:cNvSpPr txBox="1"/>
          <p:nvPr/>
        </p:nvSpPr>
        <p:spPr>
          <a:xfrm>
            <a:off x="1390438" y="7264773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B0515DB5-2198-0BD1-261B-331C1CC43A0F}"/>
              </a:ext>
            </a:extLst>
          </p:cNvPr>
          <p:cNvSpPr txBox="1"/>
          <p:nvPr/>
        </p:nvSpPr>
        <p:spPr>
          <a:xfrm>
            <a:off x="2544311" y="7264773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28E6E8D2-F0CF-7635-08AB-13818695D9FD}"/>
              </a:ext>
            </a:extLst>
          </p:cNvPr>
          <p:cNvSpPr txBox="1"/>
          <p:nvPr/>
        </p:nvSpPr>
        <p:spPr>
          <a:xfrm>
            <a:off x="5525032" y="7264773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58E86152-40C0-3EC5-B47C-887EC496857E}"/>
              </a:ext>
            </a:extLst>
          </p:cNvPr>
          <p:cNvSpPr txBox="1"/>
          <p:nvPr/>
        </p:nvSpPr>
        <p:spPr>
          <a:xfrm>
            <a:off x="6791609" y="7264773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A76C66C2-A7C7-B858-D717-0AAC2D46539E}"/>
              </a:ext>
            </a:extLst>
          </p:cNvPr>
          <p:cNvSpPr txBox="1"/>
          <p:nvPr/>
        </p:nvSpPr>
        <p:spPr>
          <a:xfrm>
            <a:off x="9759441" y="7235624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2A47FEAD-69CC-726F-A02C-A9A4AC48BC06}"/>
              </a:ext>
            </a:extLst>
          </p:cNvPr>
          <p:cNvSpPr txBox="1"/>
          <p:nvPr/>
        </p:nvSpPr>
        <p:spPr>
          <a:xfrm>
            <a:off x="10905670" y="7217020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6717F8D1-BF07-A098-4DC1-4AAD52E17891}"/>
              </a:ext>
            </a:extLst>
          </p:cNvPr>
          <p:cNvSpPr txBox="1"/>
          <p:nvPr/>
        </p:nvSpPr>
        <p:spPr>
          <a:xfrm>
            <a:off x="1405322" y="4024530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EF4E0080-96C2-16C3-95B9-1A58C94F5A70}"/>
              </a:ext>
            </a:extLst>
          </p:cNvPr>
          <p:cNvSpPr txBox="1"/>
          <p:nvPr/>
        </p:nvSpPr>
        <p:spPr>
          <a:xfrm>
            <a:off x="2507865" y="4031549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A8E53E1A-EAD9-987A-69DE-A3539E8F3A24}"/>
              </a:ext>
            </a:extLst>
          </p:cNvPr>
          <p:cNvSpPr txBox="1"/>
          <p:nvPr/>
        </p:nvSpPr>
        <p:spPr>
          <a:xfrm>
            <a:off x="5543920" y="4099462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D8599CB8-A876-D470-D910-AF42CADEE583}"/>
              </a:ext>
            </a:extLst>
          </p:cNvPr>
          <p:cNvSpPr txBox="1"/>
          <p:nvPr/>
        </p:nvSpPr>
        <p:spPr>
          <a:xfrm>
            <a:off x="6646463" y="4106481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DD4F08F9-5B11-7390-36F3-DB8D8A134D9B}"/>
              </a:ext>
            </a:extLst>
          </p:cNvPr>
          <p:cNvSpPr txBox="1"/>
          <p:nvPr/>
        </p:nvSpPr>
        <p:spPr>
          <a:xfrm>
            <a:off x="9759442" y="3976352"/>
            <a:ext cx="656233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Actual </a:t>
            </a:r>
            <a:endParaRPr lang="ko-KR" altLang="en-US" sz="10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3EDD9793-3B26-CE2E-C2F8-BFE20E640AE8}"/>
              </a:ext>
            </a:extLst>
          </p:cNvPr>
          <p:cNvSpPr txBox="1"/>
          <p:nvPr/>
        </p:nvSpPr>
        <p:spPr>
          <a:xfrm>
            <a:off x="10861985" y="3983371"/>
            <a:ext cx="774949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Predicted </a:t>
            </a:r>
            <a:endParaRPr lang="ko-KR" altLang="en-US" sz="100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681649CF-8F1A-BE31-7BC6-0C48E9FF9B97}"/>
              </a:ext>
            </a:extLst>
          </p:cNvPr>
          <p:cNvSpPr txBox="1"/>
          <p:nvPr/>
        </p:nvSpPr>
        <p:spPr>
          <a:xfrm rot="16200000">
            <a:off x="7931818" y="2362159"/>
            <a:ext cx="1779757" cy="261610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50" dirty="0"/>
              <a:t>Body fat mass (kg)</a:t>
            </a:r>
            <a:endParaRPr lang="ko-KR" altLang="en-US" sz="1050" dirty="0"/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12112411-3BB9-15BD-96F2-4DFAD9EE62C8}"/>
              </a:ext>
            </a:extLst>
          </p:cNvPr>
          <p:cNvSpPr txBox="1"/>
          <p:nvPr/>
        </p:nvSpPr>
        <p:spPr>
          <a:xfrm rot="16200000">
            <a:off x="-387876" y="5802194"/>
            <a:ext cx="1662718" cy="246221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ko-KR" sz="1000" dirty="0"/>
              <a:t>Lean body mass (kg)</a:t>
            </a:r>
            <a:endParaRPr lang="ko-KR" altLang="en-US" sz="1000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9CF38EF-56BB-5B5F-9603-974CFEE48FEC}"/>
              </a:ext>
            </a:extLst>
          </p:cNvPr>
          <p:cNvSpPr txBox="1"/>
          <p:nvPr/>
        </p:nvSpPr>
        <p:spPr>
          <a:xfrm>
            <a:off x="0" y="-31143"/>
            <a:ext cx="1295628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b="1"/>
              <a:t>Supplementary Figure </a:t>
            </a:r>
            <a:r>
              <a:rPr lang="en-US" altLang="ko-KR" b="1" dirty="0"/>
              <a:t>2. </a:t>
            </a:r>
            <a:r>
              <a:rPr lang="en-US" altLang="ko-KR" dirty="0"/>
              <a:t>Boxplots comparing actual and predicted values of body fat mass and lean body mass  in adult cancer </a:t>
            </a:r>
          </a:p>
          <a:p>
            <a:r>
              <a:rPr lang="en-US" altLang="ko-KR" dirty="0"/>
              <a:t>Survivors with obesity (body mass index</a:t>
            </a:r>
            <a:r>
              <a:rPr lang="en-US" altLang="ko-KR" dirty="0">
                <a:latin typeface="맑은 고딕" panose="020B0503020000020004" pitchFamily="50" charset="-127"/>
                <a:ea typeface="맑은 고딕" panose="020B0503020000020004" pitchFamily="50" charset="-127"/>
              </a:rPr>
              <a:t>≥</a:t>
            </a:r>
            <a:r>
              <a:rPr lang="en-US" altLang="ko-KR" dirty="0"/>
              <a:t>25.0 kg/m</a:t>
            </a:r>
            <a:r>
              <a:rPr lang="en-US" altLang="ko-KR" baseline="30000" dirty="0"/>
              <a:t>2</a:t>
            </a:r>
            <a:r>
              <a:rPr lang="en-US" altLang="ko-KR" dirty="0"/>
              <a:t>) in the Korean National Health and Nutrition Examination Survey (2008-2011)</a:t>
            </a:r>
            <a:endParaRPr lang="ko-KR" altLang="ko-KR" dirty="0"/>
          </a:p>
        </p:txBody>
      </p:sp>
    </p:spTree>
    <p:extLst>
      <p:ext uri="{BB962C8B-B14F-4D97-AF65-F5344CB8AC3E}">
        <p14:creationId xmlns:p14="http://schemas.microsoft.com/office/powerpoint/2010/main" val="10376829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8650</TotalTime>
  <Words>127</Words>
  <Application>Microsoft Office PowerPoint</Application>
  <PresentationFormat>사용자 지정</PresentationFormat>
  <Paragraphs>30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4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6" baseType="lpstr">
      <vt:lpstr>맑은 고딕</vt:lpstr>
      <vt:lpstr>Arial</vt:lpstr>
      <vt:lpstr>Calibri</vt:lpstr>
      <vt:lpstr>Calibri Light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국립암센터 호스피스완화의료사업과</dc:creator>
  <cp:lastModifiedBy>NCC</cp:lastModifiedBy>
  <cp:revision>12</cp:revision>
  <dcterms:created xsi:type="dcterms:W3CDTF">2023-06-13T23:55:47Z</dcterms:created>
  <dcterms:modified xsi:type="dcterms:W3CDTF">2023-12-27T04:49:18Z</dcterms:modified>
</cp:coreProperties>
</file>